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9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7975" autoAdjust="0"/>
    <p:restoredTop sz="96433" autoAdjust="0"/>
  </p:normalViewPr>
  <p:slideViewPr>
    <p:cSldViewPr snapToGrid="0">
      <p:cViewPr varScale="1">
        <p:scale>
          <a:sx n="85" d="100"/>
          <a:sy n="85" d="100"/>
        </p:scale>
        <p:origin x="-1290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ucdenver.pvt\som\Endo\RES-Lab\TJ%20Beadnell\Experiments\Caspase%20Assay\Das%20+%20MEKi\TJ's%20ocut2c%20k1%20dmso%20das%20tram%20combo%20(2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3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24 hours Cleaved Caspase 3/7</a:t>
            </a:r>
          </a:p>
        </c:rich>
      </c:tx>
      <c:layout/>
      <c:spPr>
        <a:noFill/>
        <a:ln>
          <a:noFill/>
        </a:ln>
        <a:effectLst/>
      </c:spPr>
    </c:title>
    <c:plotArea>
      <c:layout/>
      <c:barChart>
        <c:barDir val="col"/>
        <c:grouping val="clustered"/>
        <c:ser>
          <c:idx val="0"/>
          <c:order val="0"/>
          <c:tx>
            <c:strRef>
              <c:f>'Replicate 1'!$Q$3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accent1">
                <a:shade val="58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Replicate 1'!$V$3:$W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plus>
            <c:minus>
              <c:numRef>
                <c:f>'Replicate 1'!$V$3:$W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plicate 1'!$R$2:$S$2</c:f>
              <c:strCache>
                <c:ptCount val="2"/>
                <c:pt idx="0">
                  <c:v>OCUT-2</c:v>
                </c:pt>
                <c:pt idx="1">
                  <c:v>K1</c:v>
                </c:pt>
              </c:strCache>
            </c:strRef>
          </c:cat>
          <c:val>
            <c:numRef>
              <c:f>'Replicate 1'!$R$3:$S$3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'Replicate 1'!$Q$5</c:f>
              <c:strCache>
                <c:ptCount val="1"/>
                <c:pt idx="0">
                  <c:v>Tram 100nM </c:v>
                </c:pt>
              </c:strCache>
            </c:strRef>
          </c:tx>
          <c:spPr>
            <a:solidFill>
              <a:schemeClr val="accent1">
                <a:shade val="86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Replicate 1'!$V$5:$W$5</c:f>
                <c:numCache>
                  <c:formatCode>General</c:formatCode>
                  <c:ptCount val="2"/>
                  <c:pt idx="0">
                    <c:v>0.24289998549865124</c:v>
                  </c:pt>
                  <c:pt idx="1">
                    <c:v>3.9823171925598456E-2</c:v>
                  </c:pt>
                </c:numCache>
              </c:numRef>
            </c:plus>
            <c:minus>
              <c:numRef>
                <c:f>'Replicate 1'!$V$5:$W$5</c:f>
                <c:numCache>
                  <c:formatCode>General</c:formatCode>
                  <c:ptCount val="2"/>
                  <c:pt idx="0">
                    <c:v>0.24289998549865124</c:v>
                  </c:pt>
                  <c:pt idx="1">
                    <c:v>3.982317192559845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plicate 1'!$R$2:$S$2</c:f>
              <c:strCache>
                <c:ptCount val="2"/>
                <c:pt idx="0">
                  <c:v>OCUT-2</c:v>
                </c:pt>
                <c:pt idx="1">
                  <c:v>K1</c:v>
                </c:pt>
              </c:strCache>
            </c:strRef>
          </c:cat>
          <c:val>
            <c:numRef>
              <c:f>'Replicate 1'!$R$5:$S$5</c:f>
              <c:numCache>
                <c:formatCode>General</c:formatCode>
                <c:ptCount val="2"/>
                <c:pt idx="0">
                  <c:v>0.88817139795601274</c:v>
                </c:pt>
                <c:pt idx="1">
                  <c:v>1.065644349108916</c:v>
                </c:pt>
              </c:numCache>
            </c:numRef>
          </c:val>
        </c:ser>
        <c:ser>
          <c:idx val="2"/>
          <c:order val="2"/>
          <c:tx>
            <c:strRef>
              <c:f>'Replicate 1'!$Q$4</c:f>
              <c:strCache>
                <c:ptCount val="1"/>
                <c:pt idx="0">
                  <c:v>Das 100nM </c:v>
                </c:pt>
              </c:strCache>
            </c:strRef>
          </c:tx>
          <c:spPr>
            <a:solidFill>
              <a:schemeClr val="accent1">
                <a:tint val="86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Replicate 1'!$V$4:$W$4</c:f>
                <c:numCache>
                  <c:formatCode>General</c:formatCode>
                  <c:ptCount val="2"/>
                  <c:pt idx="0">
                    <c:v>0.15213900150246101</c:v>
                  </c:pt>
                  <c:pt idx="1">
                    <c:v>0.25848345246605475</c:v>
                  </c:pt>
                </c:numCache>
              </c:numRef>
            </c:plus>
            <c:minus>
              <c:numRef>
                <c:f>'Replicate 1'!$V$4:$W$4</c:f>
                <c:numCache>
                  <c:formatCode>General</c:formatCode>
                  <c:ptCount val="2"/>
                  <c:pt idx="0">
                    <c:v>0.15213900150246101</c:v>
                  </c:pt>
                  <c:pt idx="1">
                    <c:v>0.258483452466054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plicate 1'!$R$2:$S$2</c:f>
              <c:strCache>
                <c:ptCount val="2"/>
                <c:pt idx="0">
                  <c:v>OCUT-2</c:v>
                </c:pt>
                <c:pt idx="1">
                  <c:v>K1</c:v>
                </c:pt>
              </c:strCache>
            </c:strRef>
          </c:cat>
          <c:val>
            <c:numRef>
              <c:f>'Replicate 1'!$R$4:$S$4</c:f>
              <c:numCache>
                <c:formatCode>General</c:formatCode>
                <c:ptCount val="2"/>
                <c:pt idx="0">
                  <c:v>0.65499687900615999</c:v>
                </c:pt>
                <c:pt idx="1">
                  <c:v>2.177151580740464</c:v>
                </c:pt>
              </c:numCache>
            </c:numRef>
          </c:val>
        </c:ser>
        <c:ser>
          <c:idx val="3"/>
          <c:order val="3"/>
          <c:tx>
            <c:strRef>
              <c:f>'Replicate 1'!$Q$6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chemeClr val="accent1">
                <a:tint val="580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Replicate 1'!$V$6:$W$6</c:f>
                <c:numCache>
                  <c:formatCode>General</c:formatCode>
                  <c:ptCount val="2"/>
                  <c:pt idx="0">
                    <c:v>1.0131827922789187</c:v>
                  </c:pt>
                  <c:pt idx="1">
                    <c:v>0.43694841293041137</c:v>
                  </c:pt>
                </c:numCache>
              </c:numRef>
            </c:plus>
            <c:minus>
              <c:numRef>
                <c:f>'Replicate 1'!$V$6:$W$6</c:f>
                <c:numCache>
                  <c:formatCode>General</c:formatCode>
                  <c:ptCount val="2"/>
                  <c:pt idx="0">
                    <c:v>1.0131827922789187</c:v>
                  </c:pt>
                  <c:pt idx="1">
                    <c:v>0.436948412930411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plicate 1'!$R$2:$S$2</c:f>
              <c:strCache>
                <c:ptCount val="2"/>
                <c:pt idx="0">
                  <c:v>OCUT-2</c:v>
                </c:pt>
                <c:pt idx="1">
                  <c:v>K1</c:v>
                </c:pt>
              </c:strCache>
            </c:strRef>
          </c:cat>
          <c:val>
            <c:numRef>
              <c:f>'Replicate 1'!$R$6:$S$6</c:f>
              <c:numCache>
                <c:formatCode>General</c:formatCode>
                <c:ptCount val="2"/>
                <c:pt idx="0">
                  <c:v>3.4796776250228869</c:v>
                </c:pt>
                <c:pt idx="1">
                  <c:v>1.7467005156456921</c:v>
                </c:pt>
              </c:numCache>
            </c:numRef>
          </c:val>
        </c:ser>
        <c:dLbls/>
        <c:gapWidth val="219"/>
        <c:overlap val="-27"/>
        <c:axId val="54096640"/>
        <c:axId val="54098176"/>
      </c:barChart>
      <c:catAx>
        <c:axId val="5409664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098176"/>
        <c:crosses val="autoZero"/>
        <c:auto val="1"/>
        <c:lblAlgn val="ctr"/>
        <c:lblOffset val="100"/>
      </c:catAx>
      <c:valAx>
        <c:axId val="54098176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leaved</a:t>
                </a:r>
                <a:r>
                  <a:rPr lang="en-US" baseline="0"/>
                  <a:t> Caspase 3/7</a:t>
                </a:r>
              </a:p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(Fold Change (Relative to DMSO)</a:t>
                </a:r>
                <a:endParaRPr lang="en-US"/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0966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6992125984252"/>
          <c:y val="0.89409667541557325"/>
          <c:w val="0.76879352580927374"/>
          <c:h val="7.812554680664916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BB3CE0-A6EC-4AD1-9E4F-9645D78C58F6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9F8E10-5540-4546-AC4D-5F3C1203C6A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74923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Quantification of rpS6 phosphorylation.  </a:t>
            </a:r>
            <a:r>
              <a:rPr lang="en-US" sz="8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nsitometry quantification of rpS6 phosphorylation at S235/236 and S240/244 in BCPAP, 8505C, T238, Cal62, C643, and THJ16T cell lines following a 24 hour treatment with 100nM </a:t>
            </a:r>
            <a:r>
              <a:rPr lang="en-US" sz="8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metinib</a:t>
            </a:r>
            <a:r>
              <a:rPr lang="en-US" sz="8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100nM </a:t>
            </a:r>
            <a:r>
              <a:rPr lang="en-US" sz="800" dirty="0" err="1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satinib</a:t>
            </a:r>
            <a:r>
              <a:rPr lang="en-US" sz="8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e combination, or an equivalent amount of DMSO. Quantification is based on at least 3 independent replicates for each cell line. </a:t>
            </a:r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as means +/- SEM (n=3; student t-test; *, P &lt; 0.05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9F8E10-5540-4546-AC4D-5F3C1203C6A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82670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2037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3313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245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672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474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19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7721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486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51913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15508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25828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F9B6A-0285-4DA3-9F8D-725F6014316E}" type="datetimeFigureOut">
              <a:rPr lang="en-US" smtClean="0"/>
              <a:pPr/>
              <a:t>1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B682D-0EC1-480C-A58F-4B2A94500D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32929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89586" y="-764902"/>
            <a:ext cx="5915025" cy="1767417"/>
          </a:xfrm>
        </p:spPr>
        <p:txBody>
          <a:bodyPr>
            <a:normAutofit/>
          </a:bodyPr>
          <a:lstStyle/>
          <a:p>
            <a:r>
              <a:rPr lang="en-US" sz="2000" dirty="0" smtClean="0"/>
              <a:t>Supplemental Figure 2</a:t>
            </a:r>
            <a:endParaRPr lang="en-US" sz="2000" dirty="0"/>
          </a:p>
        </p:txBody>
      </p:sp>
      <p:sp>
        <p:nvSpPr>
          <p:cNvPr id="18" name="TextBox 17"/>
          <p:cNvSpPr txBox="1"/>
          <p:nvPr/>
        </p:nvSpPr>
        <p:spPr>
          <a:xfrm>
            <a:off x="74610" y="199739"/>
            <a:ext cx="361823" cy="348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610" y="3286664"/>
            <a:ext cx="4558699" cy="5778522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74610" y="2938154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64487779"/>
              </p:ext>
            </p:extLst>
          </p:nvPr>
        </p:nvGraphicFramePr>
        <p:xfrm>
          <a:off x="74610" y="25334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xmlns="" val="1718453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8</TotalTime>
  <Words>108</Words>
  <Application>Microsoft Office PowerPoint</Application>
  <PresentationFormat>Letter Paper (8.5x11 in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l Figur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Jamuna.c</cp:lastModifiedBy>
  <cp:revision>65</cp:revision>
  <dcterms:created xsi:type="dcterms:W3CDTF">2017-05-01T20:54:24Z</dcterms:created>
  <dcterms:modified xsi:type="dcterms:W3CDTF">2018-01-24T12:45:06Z</dcterms:modified>
</cp:coreProperties>
</file>